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F2BB927-DA4D-4AFD-A0FE-84198EF95E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9B9DC42-7145-4ECF-8358-8A7A748A7C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DCBFB48-4988-4ACA-9C2B-94A5CDBB7B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A6478AA-4961-4AF6-92D1-729CBFEAE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C87D6F-4A0F-4A2F-9441-4A09155E5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4991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CECDB2-D335-4BEA-A3EE-BCA90B8BB9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45BBFD-32C9-4F38-9CCA-BBE9E8112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68DA69-B0B1-45A8-9D15-B78F44439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55444C-CD2C-498E-B9AF-53B5A0439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BCD9A85-AB9E-463A-8463-310F06C347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42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0A9EFA7-B94D-4756-9424-D5A525E948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35056E9-43BD-440D-B9F0-D548D98340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F5CB4A-D15F-4207-8F51-A79F72964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551AA94-7D1B-423C-A453-60DD452AD9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1AEB2E-7625-48BD-8056-096A3E40F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9684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C70277-B0BA-4FF8-A686-C6E06BB92A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7D5EF77-C320-4EAB-BE5B-526E281AF0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87A044-1A4E-4901-91B6-65F509A6C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D97925D-2B85-4AE9-9879-56033765C5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17FAA3-449C-4E6C-8BA1-B84816C93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054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CA3644-D6D5-4003-98BF-3BC390F0EB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5BA097-0FB9-4D7F-B3D8-BC46FE60D0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9B58C9-F1D6-4DA0-B461-0790D1EC0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237A5A-3674-45DE-A52C-3AAE826226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7F75CA-8C58-469E-A0B9-3A711E48F8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3859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F97B7E-108F-456E-8177-4FE3DA1C9A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4839F5C-D324-4FAB-A223-28FAEFFCA6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D8CB277-57E7-424A-B9DB-1D53C4EFE0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5D2BAD9-9CE9-42AD-9E1F-2C76C386A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61D68D-113F-4A5F-9159-A9FDE39BC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53BDA99-B7B5-494D-BA5C-4F0AEAE0F1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627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777421-AE62-46E8-8F1F-6662E98156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72272C5-AC78-4A43-A567-26FBEB7FF2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3E0D3E0-DD77-4F26-9F19-C91AB4929C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1F36E4A-FDBC-4CE5-A97C-B482AE9DB7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8E40DEF-1EA7-4347-805F-93C47EC2E0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73EB522-811D-417B-90AD-A12F928F6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AE08201-5951-4511-BDFD-E0A156BCD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FED299F-8444-4646-ADD6-5937DD512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29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5268716-9FD6-46FA-8D65-E704676C9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BB7C7D3-0FA3-4126-B71F-32B10945D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CA786E3-D759-4544-9081-A3CCCF1C7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9268CBF-41DF-4AA5-ABF4-E9124B938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4708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30829889-60C4-401F-ACD6-4BB00C277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702B803-63FD-4C5F-A435-79AC0317F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196C6DD-8B71-4CB0-9AC6-3E7C4D00C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8995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FF1D8E-DCFF-4D84-8164-9713A0F76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34D370-0247-48B2-AD92-2D2D4E4E49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7E77F4AD-D792-4066-8864-3DD49C4D67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FF24FFB-8602-46EE-A382-C9835008B6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BED0CB5-75A3-4C44-BA92-83F1D4C56B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9AE5C31-6237-4B68-950D-405C69EFB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506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E57D41-579A-444D-A59E-2E51A5AE2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D664E08-BEB3-402A-8066-6F573FA3E95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397B9A1-1B44-499B-92DC-387B82A6D2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111799-4264-451E-B976-31AE2F49C6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C33DA9D-B396-4518-93D3-94BF1D8D3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4592B91-AB6B-4CFD-A979-63E8947FBE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2037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7B7BE1F-551C-4B30-BA11-9D3076CD79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89E202-90E6-49C2-AB7F-C0E1F19679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2C5736-90A3-4BFC-B374-72491134BF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8DC1AC-67C8-41C5-902D-FECF7B48C311}" type="datetimeFigureOut">
              <a:rPr lang="zh-CN" altLang="en-US" smtClean="0"/>
              <a:t>2020/5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BA2B2C-D1FF-4C83-BCE0-02F1E37C015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11D45B-8EE5-4E6D-B5B9-01631B906E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34F2E-6674-463A-8BBF-8A90F5BAEB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15233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BED72CC-01BB-4772-845D-199D50DCE1D0}"/>
              </a:ext>
            </a:extLst>
          </p:cNvPr>
          <p:cNvGrpSpPr/>
          <p:nvPr/>
        </p:nvGrpSpPr>
        <p:grpSpPr>
          <a:xfrm>
            <a:off x="781307" y="53165"/>
            <a:ext cx="2716799" cy="3093481"/>
            <a:chOff x="664761" y="145532"/>
            <a:chExt cx="2716799" cy="3093481"/>
          </a:xfrm>
        </p:grpSpPr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B51557AD-C322-465E-909D-FE478980B976}"/>
                </a:ext>
              </a:extLst>
            </p:cNvPr>
            <p:cNvGrpSpPr/>
            <p:nvPr/>
          </p:nvGrpSpPr>
          <p:grpSpPr>
            <a:xfrm>
              <a:off x="664761" y="303248"/>
              <a:ext cx="2716799" cy="2935765"/>
              <a:chOff x="8110171" y="3700025"/>
              <a:chExt cx="3065143" cy="3160454"/>
            </a:xfrm>
          </p:grpSpPr>
          <p:pic>
            <p:nvPicPr>
              <p:cNvPr id="33" name="图片 32">
                <a:extLst>
                  <a:ext uri="{FF2B5EF4-FFF2-40B4-BE49-F238E27FC236}">
                    <a16:creationId xmlns:a16="http://schemas.microsoft.com/office/drawing/2014/main" id="{91CE16CA-391E-4E0C-9491-F175D092CF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12202" r="1489"/>
              <a:stretch/>
            </p:blipFill>
            <p:spPr>
              <a:xfrm>
                <a:off x="8110171" y="4034818"/>
                <a:ext cx="3026065" cy="2825661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55D25947-7AAD-4547-B5B1-BDC617B908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8813"/>
              <a:stretch/>
            </p:blipFill>
            <p:spPr>
              <a:xfrm>
                <a:off x="8110171" y="3700025"/>
                <a:ext cx="3065143" cy="360040"/>
              </a:xfrm>
              <a:prstGeom prst="rect">
                <a:avLst/>
              </a:prstGeom>
            </p:spPr>
          </p:pic>
        </p:grp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D09D596-5F38-49CC-9F12-D79742E7D556}"/>
                </a:ext>
              </a:extLst>
            </p:cNvPr>
            <p:cNvSpPr txBox="1"/>
            <p:nvPr/>
          </p:nvSpPr>
          <p:spPr>
            <a:xfrm>
              <a:off x="789324" y="145532"/>
              <a:ext cx="1329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lasma_po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3842E832-0856-4491-8AFC-4FF440E2D6E2}"/>
              </a:ext>
            </a:extLst>
          </p:cNvPr>
          <p:cNvGrpSpPr/>
          <p:nvPr/>
        </p:nvGrpSpPr>
        <p:grpSpPr>
          <a:xfrm>
            <a:off x="4294535" y="63798"/>
            <a:ext cx="3141569" cy="3036702"/>
            <a:chOff x="4385244" y="160685"/>
            <a:chExt cx="3141569" cy="3036702"/>
          </a:xfrm>
        </p:grpSpPr>
        <p:grpSp>
          <p:nvGrpSpPr>
            <p:cNvPr id="35" name="组合 34">
              <a:extLst>
                <a:ext uri="{FF2B5EF4-FFF2-40B4-BE49-F238E27FC236}">
                  <a16:creationId xmlns:a16="http://schemas.microsoft.com/office/drawing/2014/main" id="{68D0D433-828A-4004-A491-2E4A255695C5}"/>
                </a:ext>
              </a:extLst>
            </p:cNvPr>
            <p:cNvGrpSpPr/>
            <p:nvPr/>
          </p:nvGrpSpPr>
          <p:grpSpPr>
            <a:xfrm>
              <a:off x="4385244" y="285900"/>
              <a:ext cx="3141569" cy="2911487"/>
              <a:chOff x="8163490" y="3697287"/>
              <a:chExt cx="3141569" cy="3132616"/>
            </a:xfrm>
          </p:grpSpPr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5BCF0E6F-57C9-43A7-8B97-D572F06A2F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9834" r="220"/>
              <a:stretch/>
            </p:blipFill>
            <p:spPr>
              <a:xfrm>
                <a:off x="8163490" y="3956103"/>
                <a:ext cx="2862884" cy="2873800"/>
              </a:xfrm>
              <a:prstGeom prst="rect">
                <a:avLst/>
              </a:prstGeom>
            </p:spPr>
          </p:pic>
          <p:pic>
            <p:nvPicPr>
              <p:cNvPr id="37" name="图片 36">
                <a:extLst>
                  <a:ext uri="{FF2B5EF4-FFF2-40B4-BE49-F238E27FC236}">
                    <a16:creationId xmlns:a16="http://schemas.microsoft.com/office/drawing/2014/main" id="{F5AAF612-A018-41BE-8A90-F9717B2E01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8813"/>
              <a:stretch/>
            </p:blipFill>
            <p:spPr>
              <a:xfrm>
                <a:off x="8239916" y="3697287"/>
                <a:ext cx="3065143" cy="360040"/>
              </a:xfrm>
              <a:prstGeom prst="rect">
                <a:avLst/>
              </a:prstGeom>
            </p:spPr>
          </p:pic>
        </p:grp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A05269A-1351-490A-9EFF-EEAD96E0F938}"/>
                </a:ext>
              </a:extLst>
            </p:cNvPr>
            <p:cNvSpPr txBox="1"/>
            <p:nvPr/>
          </p:nvSpPr>
          <p:spPr>
            <a:xfrm>
              <a:off x="4408725" y="160685"/>
              <a:ext cx="16267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MV_pos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" name="组合 3">
            <a:extLst>
              <a:ext uri="{FF2B5EF4-FFF2-40B4-BE49-F238E27FC236}">
                <a16:creationId xmlns:a16="http://schemas.microsoft.com/office/drawing/2014/main" id="{22D977D7-8BC8-435C-9F12-40A7F79BFC84}"/>
              </a:ext>
            </a:extLst>
          </p:cNvPr>
          <p:cNvGrpSpPr/>
          <p:nvPr/>
        </p:nvGrpSpPr>
        <p:grpSpPr>
          <a:xfrm>
            <a:off x="8003509" y="0"/>
            <a:ext cx="2779445" cy="3108346"/>
            <a:chOff x="8162221" y="89040"/>
            <a:chExt cx="2779445" cy="3108346"/>
          </a:xfrm>
        </p:grpSpPr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0A7E58B1-82DA-49F2-A852-CF67B1394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62221" y="278969"/>
              <a:ext cx="2779445" cy="2918417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341139BC-5B8B-453C-B3AF-3344C5AC7C3F}"/>
                </a:ext>
              </a:extLst>
            </p:cNvPr>
            <p:cNvSpPr txBox="1"/>
            <p:nvPr/>
          </p:nvSpPr>
          <p:spPr>
            <a:xfrm>
              <a:off x="8187339" y="89040"/>
              <a:ext cx="1329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o_pos</a:t>
              </a:r>
              <a:endPara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B79ADD07-EBB5-4650-B577-011C050B556C}"/>
              </a:ext>
            </a:extLst>
          </p:cNvPr>
          <p:cNvGrpSpPr/>
          <p:nvPr/>
        </p:nvGrpSpPr>
        <p:grpSpPr>
          <a:xfrm>
            <a:off x="734265" y="3093482"/>
            <a:ext cx="3065143" cy="3076068"/>
            <a:chOff x="607136" y="3397103"/>
            <a:chExt cx="3065143" cy="3076068"/>
          </a:xfrm>
        </p:grpSpPr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1B051384-88EC-48E3-9C24-852040C2F0BC}"/>
                </a:ext>
              </a:extLst>
            </p:cNvPr>
            <p:cNvGrpSpPr/>
            <p:nvPr/>
          </p:nvGrpSpPr>
          <p:grpSpPr>
            <a:xfrm>
              <a:off x="607136" y="3544918"/>
              <a:ext cx="3065143" cy="2928253"/>
              <a:chOff x="8063585" y="586282"/>
              <a:chExt cx="3065143" cy="2907640"/>
            </a:xfrm>
          </p:grpSpPr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00D84768-0CCE-4F09-804D-2EC608E3F96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t="9606"/>
              <a:stretch/>
            </p:blipFill>
            <p:spPr>
              <a:xfrm>
                <a:off x="8110171" y="887996"/>
                <a:ext cx="2746350" cy="2605926"/>
              </a:xfrm>
              <a:prstGeom prst="rect">
                <a:avLst/>
              </a:prstGeom>
            </p:spPr>
          </p:pic>
          <p:pic>
            <p:nvPicPr>
              <p:cNvPr id="31" name="图片 30">
                <a:extLst>
                  <a:ext uri="{FF2B5EF4-FFF2-40B4-BE49-F238E27FC236}">
                    <a16:creationId xmlns:a16="http://schemas.microsoft.com/office/drawing/2014/main" id="{F583D14B-3AB0-49B3-806B-C973C76D2C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8813"/>
              <a:stretch/>
            </p:blipFill>
            <p:spPr>
              <a:xfrm>
                <a:off x="8063585" y="586282"/>
                <a:ext cx="3065143" cy="360040"/>
              </a:xfrm>
              <a:prstGeom prst="rect">
                <a:avLst/>
              </a:prstGeom>
            </p:spPr>
          </p:pic>
        </p:grp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D7C20525-6595-4E1B-AF7C-71A421E43760}"/>
                </a:ext>
              </a:extLst>
            </p:cNvPr>
            <p:cNvSpPr txBox="1"/>
            <p:nvPr/>
          </p:nvSpPr>
          <p:spPr>
            <a:xfrm>
              <a:off x="863101" y="3397103"/>
              <a:ext cx="132906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zh-CN" sz="1200" b="1" dirty="0" err="1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Plasma_ne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B55A171A-BBBE-4DD5-B417-D70C72536F72}"/>
              </a:ext>
            </a:extLst>
          </p:cNvPr>
          <p:cNvGrpSpPr/>
          <p:nvPr/>
        </p:nvGrpSpPr>
        <p:grpSpPr>
          <a:xfrm>
            <a:off x="4250085" y="3045893"/>
            <a:ext cx="3262983" cy="3106676"/>
            <a:chOff x="4402961" y="3486684"/>
            <a:chExt cx="3262983" cy="3106676"/>
          </a:xfrm>
        </p:grpSpPr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0B46A9EF-80D8-4065-A96B-0E43C7B90AE3}"/>
                </a:ext>
              </a:extLst>
            </p:cNvPr>
            <p:cNvGrpSpPr/>
            <p:nvPr/>
          </p:nvGrpSpPr>
          <p:grpSpPr>
            <a:xfrm>
              <a:off x="4402961" y="3651064"/>
              <a:ext cx="3262983" cy="2942296"/>
              <a:chOff x="8144248" y="723705"/>
              <a:chExt cx="3065143" cy="2773334"/>
            </a:xfrm>
          </p:grpSpPr>
          <p:pic>
            <p:nvPicPr>
              <p:cNvPr id="39" name="图片 38">
                <a:extLst>
                  <a:ext uri="{FF2B5EF4-FFF2-40B4-BE49-F238E27FC236}">
                    <a16:creationId xmlns:a16="http://schemas.microsoft.com/office/drawing/2014/main" id="{9357413F-CD75-4C59-8ADF-D2CA30BF539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9986" r="220"/>
              <a:stretch/>
            </p:blipFill>
            <p:spPr>
              <a:xfrm>
                <a:off x="8184116" y="1005035"/>
                <a:ext cx="2631580" cy="2492004"/>
              </a:xfrm>
              <a:prstGeom prst="rect">
                <a:avLst/>
              </a:prstGeom>
            </p:spPr>
          </p:pic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77DB7EFC-76A0-4129-8126-848C64C0C3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88813"/>
              <a:stretch/>
            </p:blipFill>
            <p:spPr>
              <a:xfrm>
                <a:off x="8144248" y="723705"/>
                <a:ext cx="3065143" cy="360040"/>
              </a:xfrm>
              <a:prstGeom prst="rect">
                <a:avLst/>
              </a:prstGeom>
            </p:spPr>
          </p:pic>
        </p:grp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DA30B6DD-3F62-439B-987D-0D149BACF12C}"/>
                </a:ext>
              </a:extLst>
            </p:cNvPr>
            <p:cNvSpPr txBox="1"/>
            <p:nvPr/>
          </p:nvSpPr>
          <p:spPr>
            <a:xfrm>
              <a:off x="4599467" y="3486684"/>
              <a:ext cx="16267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MV_</a:t>
              </a:r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neg</a:t>
              </a:r>
              <a:endParaRPr kumimoji="0" lang="zh-CN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07C5F5E5-E815-478C-81E9-02FAC2F5168F}"/>
              </a:ext>
            </a:extLst>
          </p:cNvPr>
          <p:cNvGrpSpPr/>
          <p:nvPr/>
        </p:nvGrpSpPr>
        <p:grpSpPr>
          <a:xfrm>
            <a:off x="7943041" y="3009477"/>
            <a:ext cx="2849006" cy="3146773"/>
            <a:chOff x="8260837" y="3471532"/>
            <a:chExt cx="2801471" cy="3132464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7C6AF716-AF6B-4324-9527-12A10EFD5C1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60837" y="3662453"/>
              <a:ext cx="2801471" cy="2941543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1E3CD19C-0821-4F51-8372-B214420129E9}"/>
                </a:ext>
              </a:extLst>
            </p:cNvPr>
            <p:cNvSpPr txBox="1"/>
            <p:nvPr/>
          </p:nvSpPr>
          <p:spPr>
            <a:xfrm>
              <a:off x="8377527" y="3471532"/>
              <a:ext cx="1329069" cy="275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lvl="0"/>
              <a:r>
                <a:rPr lang="en-US" altLang="zh-CN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xo_neg</a:t>
              </a:r>
            </a:p>
          </p:txBody>
        </p:sp>
      </p:grpSp>
      <p:sp>
        <p:nvSpPr>
          <p:cNvPr id="11" name="文本框 10">
            <a:extLst>
              <a:ext uri="{FF2B5EF4-FFF2-40B4-BE49-F238E27FC236}">
                <a16:creationId xmlns:a16="http://schemas.microsoft.com/office/drawing/2014/main" id="{E7D6ABC8-F890-43C5-8D87-92DC2A7C6107}"/>
              </a:ext>
            </a:extLst>
          </p:cNvPr>
          <p:cNvSpPr txBox="1"/>
          <p:nvPr/>
        </p:nvSpPr>
        <p:spPr>
          <a:xfrm>
            <a:off x="191386" y="6211669"/>
            <a:ext cx="1200061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Principal component analysis (PCA) score plots with QC samples of plasma (A),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crovesicles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and exosomes (C) in positive and negative mode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0D418609-8BAC-40F6-B181-24579A28AE6E}"/>
              </a:ext>
            </a:extLst>
          </p:cNvPr>
          <p:cNvSpPr txBox="1"/>
          <p:nvPr/>
        </p:nvSpPr>
        <p:spPr>
          <a:xfrm>
            <a:off x="154425" y="167009"/>
            <a:ext cx="8718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FE2CE9B-31BD-4C94-8CA9-F036DE82428A}"/>
              </a:ext>
            </a:extLst>
          </p:cNvPr>
          <p:cNvSpPr txBox="1"/>
          <p:nvPr/>
        </p:nvSpPr>
        <p:spPr>
          <a:xfrm>
            <a:off x="3804949" y="159920"/>
            <a:ext cx="871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7DABC1E2-9DD3-4FD7-93FC-6E1B4821ABD4}"/>
              </a:ext>
            </a:extLst>
          </p:cNvPr>
          <p:cNvSpPr txBox="1"/>
          <p:nvPr/>
        </p:nvSpPr>
        <p:spPr>
          <a:xfrm>
            <a:off x="7476734" y="152832"/>
            <a:ext cx="8718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6850804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</TotalTime>
  <Words>55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1_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倩倩(Qianqian Zhao)</dc:creator>
  <cp:lastModifiedBy>赵倩倩(Qianqian Zhao)</cp:lastModifiedBy>
  <cp:revision>10</cp:revision>
  <dcterms:created xsi:type="dcterms:W3CDTF">2019-10-29T02:41:17Z</dcterms:created>
  <dcterms:modified xsi:type="dcterms:W3CDTF">2020-05-18T07:16:56Z</dcterms:modified>
</cp:coreProperties>
</file>